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 showGuides="1">
      <p:cViewPr>
        <p:scale>
          <a:sx n="200" d="100"/>
          <a:sy n="200" d="100"/>
        </p:scale>
        <p:origin x="240" y="379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10" cy="7201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4824855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032546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32206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5071090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8964818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084358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201509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33825640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40078672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20930150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CH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CH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1940894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e-CH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e-CH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6A977F-D681-4A15-82E6-08C63BC4F348}" type="datetimeFigureOut">
              <a:rPr lang="de-CH" smtClean="0"/>
              <a:t>26.09.2017</a:t>
            </a:fld>
            <a:endParaRPr lang="de-CH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CH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8B0BE9-B5E4-4601-B73D-10CD199F630F}" type="slidenum">
              <a:rPr lang="de-CH" smtClean="0"/>
              <a:t>‹#›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7390417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22285969"/>
              </p:ext>
            </p:extLst>
          </p:nvPr>
        </p:nvGraphicFramePr>
        <p:xfrm>
          <a:off x="549828" y="257171"/>
          <a:ext cx="4653441" cy="6034099"/>
        </p:xfrm>
        <a:graphic>
          <a:graphicData uri="http://schemas.openxmlformats.org/drawingml/2006/table">
            <a:tbl>
              <a:tblPr/>
              <a:tblGrid>
                <a:gridCol w="247851"/>
                <a:gridCol w="478409"/>
                <a:gridCol w="1786829"/>
                <a:gridCol w="432297"/>
                <a:gridCol w="432297"/>
                <a:gridCol w="637879"/>
                <a:gridCol w="637879"/>
              </a:tblGrid>
              <a:tr h="109606">
                <a:tc gridSpan="3">
                  <a:txBody>
                    <a:bodyPr/>
                    <a:lstStyle/>
                    <a:p>
                      <a:pPr algn="l" fontAlgn="b"/>
                      <a:r>
                        <a:rPr lang="de-CH" sz="6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4 Table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6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600" b="1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he 50 most dysregulated genes in sEH KO vs WT liver ranked by </a:t>
                      </a:r>
                      <a:r>
                        <a:rPr lang="en-US" sz="6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</a:t>
                      </a:r>
                      <a:endParaRPr lang="en-US" sz="600" b="1" i="0" u="none" strike="noStrike" dirty="0">
                        <a:solidFill>
                          <a:srgbClr val="000000"/>
                        </a:solidFill>
                        <a:effectLst/>
                        <a:latin typeface="Arial"/>
                      </a:endParaRP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109606"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EH KO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WT control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</a:tr>
              <a:tr h="115375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ank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ene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tein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og2 Ratio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 fontAlgn="b"/>
                      <a:r>
                        <a:rPr lang="de-CH" sz="500" b="1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ounts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m2072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edicted gene, 2072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6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46E-7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2.2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5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phx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epoxide hydrolase 2, cytoplasmic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.5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8E-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0.7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824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nx2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rting nexin 2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2E-6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1.9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ap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idney androgen regulated protein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.7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12E-3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4.2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yom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yomesin 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0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8E-3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7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2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xd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onooxygenase, DBH-like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7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4E-3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17.1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4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and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CAN domain-containing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16E-1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6.3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3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t-Nd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tochondrially encoded NADH dehydrogenase 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9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2E-1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25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34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rrc6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leucine rich repeat containing 6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2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1E-1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3.6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3.5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a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chrome P450, family 2, subfamily a, polypeptide 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5.7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80E-1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.7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78.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p1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jor urinary protein 1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8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6E-1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4.7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4.8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p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jor urinary protein 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3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44E-1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5.1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2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lec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eleted in lung and esophageal cancer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5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78E-1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3.0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7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lf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Kruppel-like factor 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2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4E-1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77.2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5.8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c34a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ute carrier family 34 (sodium phosphate), member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4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53E-1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.1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6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cn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yperpolarization-activated, cyclic nucleotide-gated K</a:t>
                      </a:r>
                      <a:r>
                        <a:rPr lang="en-US" sz="500" b="0" i="0" u="none" strike="noStrike" baseline="3000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+</a:t>
                      </a:r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 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8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07E-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.8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6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7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4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chrome P450, family 2, subfamily c, polypeptide 4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1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29E-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9.7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26.5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p2c6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tochrome P450, family 2, subfamily c, polypeptide 6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3.3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92E-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6.3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84.5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up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jor urinary protein 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17E-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011.7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3.7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3gal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T3 beta-galactoside alpha-2,3-sialyltransferase 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10E-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20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394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17H6S56E-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DNA segment, Chr 17, human D6S56E 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7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34E-1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.8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93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2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uggc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uclear GTPase, germinal center associated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5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36E-1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.8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0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ta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s-E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utathione S-transferase, alpha 1 (Ya)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4.6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77E-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.3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43.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mod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uromodulin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5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42E-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.9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3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a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rc-like-adaptor 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42E-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5.2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6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fp36l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nb-NO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inc finger protein 36, C3H type-like 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00E-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50.6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6.5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7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ckr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atypical chemokine receptor 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3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1E-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.6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m2660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edicted gene, 2660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5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64E-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.4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9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4bp2l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EDD4 binding protein 2-like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14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16.6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8.4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0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830403L1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RIKEN cDNA 5830403L16 gene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9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4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.3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9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aqr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ogestin and adipoQ receptor family member VII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7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75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4.9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7.4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2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fp77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zinc finger protein 77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28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09.9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.9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m8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redicted gene 8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.0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7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5.7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2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4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tm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utathione S-transferase, mu 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9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40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84.5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19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5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cm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fr-FR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nichromosome maintenance deficient 6 (MIS5 homolog) 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3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40E-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8.8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49.1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c25a4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ute carrier family 25, member 4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8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4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714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312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7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ff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refoil factor 3, intestinal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2.2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69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9.0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7.3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8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pnmb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lycoprotein (transmembrane) nmb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8.7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69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0.8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5.2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9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crod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CRO domain containing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17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4.0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5.1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0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pgs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tubulin polyglutamylase complex subunit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2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17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51.7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1.5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1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c1a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ute carrier family 1, member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7.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92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6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18.4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2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st1h2bc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histone cluster 1, H2bc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.53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33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88.4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3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as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rowth arrest specific 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.32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43.4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6.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4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nt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nicotinamide nucleotide transhydrogenase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55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820.3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718.5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5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lc17a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solute carrier family 17, member 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55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56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67.6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26.0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6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0s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0/G1 switch gene 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.5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56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192.1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00.4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ap3k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togen-activated protein kinase kinase kinase 12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3.3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85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7.6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.6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8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nd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yclin D1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-1.3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8.98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1.9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07.8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49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ebpb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CAAT/enhancer binding protein (C/EBP), beta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39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9.79E-08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645.1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8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</a:tr>
              <a:tr h="109606"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50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dn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claudin 3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44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1.21E-07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238.0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6.10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  <a:tr h="109606">
                <a:tc gridSpan="2"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fdr false discovery rate </a:t>
                      </a:r>
                    </a:p>
                  </a:txBody>
                  <a:tcPr marL="5769" marR="5769" marT="5769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de-CH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CH" sz="5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 </a:t>
                      </a:r>
                    </a:p>
                  </a:txBody>
                  <a:tcPr marL="5769" marR="5769" marT="5769" marB="0" anchor="b">
                    <a:lnL>
                      <a:noFill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3944342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05</Words>
  <Application>Microsoft Office PowerPoint</Application>
  <PresentationFormat>On-screen Show (4:3)</PresentationFormat>
  <Paragraphs>37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ät Zürich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ne Morowsky</dc:creator>
  <cp:lastModifiedBy>Anne Morowsky</cp:lastModifiedBy>
  <cp:revision>3</cp:revision>
  <dcterms:created xsi:type="dcterms:W3CDTF">2017-09-26T13:13:10Z</dcterms:created>
  <dcterms:modified xsi:type="dcterms:W3CDTF">2017-09-26T13:42:53Z</dcterms:modified>
</cp:coreProperties>
</file>